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8739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2291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3676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1656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097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2926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6997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1720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7977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2374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7447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6C29B-7C97-489E-A7FC-1D8C422566E1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86198-9ED8-4F48-A7DA-5D5F7556CF8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3496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631" y="1466744"/>
            <a:ext cx="3738268" cy="2849639"/>
          </a:xfrm>
          <a:prstGeom prst="rect">
            <a:avLst/>
          </a:prstGeom>
        </p:spPr>
      </p:pic>
      <p:sp>
        <p:nvSpPr>
          <p:cNvPr id="6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4062427" y="1416443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1169700" y="4705101"/>
            <a:ext cx="717448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3.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n-GB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 and RSP25 RNA stability in METTL3 knockdown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m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 total content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using Liquid Chromatography Mass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tometry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LC-MS/MS)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in pLKO.1-TRC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mpt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vector (EV) and shRNA-METTL3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deplet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(sh2.1) BLaER1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fter 168 hours of transdifferentiation (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Actinomyci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has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deca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of RPS25 mRNA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V and sh2.1 BLaER1 cells upon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T-Student test (P-Valu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.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upo 20"/>
          <p:cNvGrpSpPr/>
          <p:nvPr/>
        </p:nvGrpSpPr>
        <p:grpSpPr>
          <a:xfrm>
            <a:off x="1393031" y="1601109"/>
            <a:ext cx="2204029" cy="2725260"/>
            <a:chOff x="1393031" y="1420134"/>
            <a:chExt cx="2204029" cy="2725260"/>
          </a:xfrm>
        </p:grpSpPr>
        <p:pic>
          <p:nvPicPr>
            <p:cNvPr id="13" name="Imagen 12"/>
            <p:cNvPicPr>
              <a:picLocks noChangeAspect="1"/>
            </p:cNvPicPr>
            <p:nvPr/>
          </p:nvPicPr>
          <p:blipFill rotWithShape="1">
            <a:blip r:embed="rId3"/>
            <a:srcRect l="13569" t="12211" b="22855"/>
            <a:stretch/>
          </p:blipFill>
          <p:spPr>
            <a:xfrm>
              <a:off x="1624330" y="1669044"/>
              <a:ext cx="1972730" cy="2082800"/>
            </a:xfrm>
            <a:prstGeom prst="rect">
              <a:avLst/>
            </a:prstGeom>
          </p:spPr>
        </p:pic>
        <p:sp>
          <p:nvSpPr>
            <p:cNvPr id="14" name="CuadroTexto 13"/>
            <p:cNvSpPr txBox="1"/>
            <p:nvPr/>
          </p:nvSpPr>
          <p:spPr>
            <a:xfrm>
              <a:off x="2094626" y="3682028"/>
              <a:ext cx="3738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cxnSp>
          <p:nvCxnSpPr>
            <p:cNvPr id="15" name="Conector recto 14"/>
            <p:cNvCxnSpPr/>
            <p:nvPr/>
          </p:nvCxnSpPr>
          <p:spPr>
            <a:xfrm>
              <a:off x="2117459" y="3908487"/>
              <a:ext cx="8929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CuadroTexto 15"/>
            <p:cNvSpPr txBox="1"/>
            <p:nvPr/>
          </p:nvSpPr>
          <p:spPr>
            <a:xfrm>
              <a:off x="2289348" y="3883784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168h</a:t>
              </a: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2569310" y="3673538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sh2.1</a:t>
              </a: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1911092" y="1420134"/>
              <a:ext cx="12025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s-E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LC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-MS/MS</a:t>
              </a:r>
            </a:p>
          </p:txBody>
        </p:sp>
        <p:sp>
          <p:nvSpPr>
            <p:cNvPr id="19" name="CuadroTexto 18"/>
            <p:cNvSpPr txBox="1"/>
            <p:nvPr/>
          </p:nvSpPr>
          <p:spPr>
            <a:xfrm rot="16200000">
              <a:off x="755837" y="2563726"/>
              <a:ext cx="15359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s-ES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A total </a:t>
              </a:r>
              <a:r>
                <a:rPr lang="es-E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es-ES" sz="1100" dirty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</a:p>
          </p:txBody>
        </p:sp>
      </p:grpSp>
      <p:sp>
        <p:nvSpPr>
          <p:cNvPr id="20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1313836" y="1416443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254961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02</Words>
  <Application>Microsoft Office PowerPoint</Application>
  <PresentationFormat>Presentación en pantalla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7</cp:revision>
  <dcterms:created xsi:type="dcterms:W3CDTF">2022-03-31T19:00:40Z</dcterms:created>
  <dcterms:modified xsi:type="dcterms:W3CDTF">2022-04-05T18:12:15Z</dcterms:modified>
</cp:coreProperties>
</file>